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6046" userDrawn="1">
          <p15:clr>
            <a:srgbClr val="A4A3A4"/>
          </p15:clr>
        </p15:guide>
        <p15:guide id="2" pos="3884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9" roundtripDataSignature="AMtx7midwCLYT89+EyjzX2RZb8vAvdRXAA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DAC5F1A-6898-D71F-6AE6-81726EC0ABCA}" name="Ali A" initials="AA" userId="12429a67cc4e76dc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E32713-2377-47DB-8176-DB4D2CB9FCFD}">
  <a:tblStyle styleId="{5CE32713-2377-47DB-8176-DB4D2CB9FCFD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3"/>
    <p:restoredTop sz="94654"/>
  </p:normalViewPr>
  <p:slideViewPr>
    <p:cSldViewPr snapToGrid="0">
      <p:cViewPr varScale="1">
        <p:scale>
          <a:sx n="72" d="100"/>
          <a:sy n="72" d="100"/>
        </p:scale>
        <p:origin x="2824" y="200"/>
      </p:cViewPr>
      <p:guideLst>
        <p:guide orient="horz" pos="6046"/>
        <p:guide pos="388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viewProps" Target="viewProps.xml"/><Relationship Id="rId5" Type="http://schemas.openxmlformats.org/officeDocument/2006/relationships/notesMaster" Target="notesMasters/notesMaster1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customschemas.google.com/relationships/presentationmetadata" Target="metadata"/><Relationship Id="rId14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CA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gb94cefe6b1_1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4" name="Google Shape;74;gb94cefe6b1_1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5" name="Google Shape;75;gb94cefe6b1_1_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CA"/>
              <a:t>2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1" name="Google Shape;8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0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0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0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5" name="Google Shape;25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11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4" name="Google Shape;34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1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4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49" name="Google Shape;49;p14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0" name="Google Shape;50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5" name="Google Shape;65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7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8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AA25595-E87E-BA4E-BE29-68AB800EEF36}"/>
              </a:ext>
            </a:extLst>
          </p:cNvPr>
          <p:cNvGrpSpPr/>
          <p:nvPr/>
        </p:nvGrpSpPr>
        <p:grpSpPr>
          <a:xfrm>
            <a:off x="268941" y="1644789"/>
            <a:ext cx="6767761" cy="7402720"/>
            <a:chOff x="268941" y="1644789"/>
            <a:chExt cx="6767761" cy="7402720"/>
          </a:xfrm>
        </p:grpSpPr>
        <p:grpSp>
          <p:nvGrpSpPr>
            <p:cNvPr id="5" name="Google Shape;76;p1">
              <a:extLst>
                <a:ext uri="{FF2B5EF4-FFF2-40B4-BE49-F238E27FC236}">
                  <a16:creationId xmlns:a16="http://schemas.microsoft.com/office/drawing/2014/main" id="{EC2CEB09-E05B-F644-BAE9-60B38E4079DC}"/>
                </a:ext>
              </a:extLst>
            </p:cNvPr>
            <p:cNvGrpSpPr/>
            <p:nvPr/>
          </p:nvGrpSpPr>
          <p:grpSpPr>
            <a:xfrm>
              <a:off x="1201958" y="4234129"/>
              <a:ext cx="2581730" cy="859971"/>
              <a:chOff x="634997" y="931079"/>
              <a:chExt cx="2581730" cy="859971"/>
            </a:xfrm>
          </p:grpSpPr>
          <p:sp>
            <p:nvSpPr>
              <p:cNvPr id="6" name="Google Shape;77;p1">
                <a:extLst>
                  <a:ext uri="{FF2B5EF4-FFF2-40B4-BE49-F238E27FC236}">
                    <a16:creationId xmlns:a16="http://schemas.microsoft.com/office/drawing/2014/main" id="{6B8D5D4C-EC40-844B-8D36-3C633013BC43}"/>
                  </a:ext>
                </a:extLst>
              </p:cNvPr>
              <p:cNvSpPr txBox="1"/>
              <p:nvPr/>
            </p:nvSpPr>
            <p:spPr>
              <a:xfrm>
                <a:off x="634997" y="991752"/>
                <a:ext cx="2579914" cy="73862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en-CA" sz="1400" b="1" i="0" u="none" strike="noStrike" cap="none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409 Francophone immigrants originating from Sub-Saharan Africa recruited</a:t>
                </a:r>
                <a:endParaRPr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" name="Google Shape;78;p1">
                <a:extLst>
                  <a:ext uri="{FF2B5EF4-FFF2-40B4-BE49-F238E27FC236}">
                    <a16:creationId xmlns:a16="http://schemas.microsoft.com/office/drawing/2014/main" id="{40E2B86C-B6B1-5241-A89C-A8E42106B08A}"/>
                  </a:ext>
                </a:extLst>
              </p:cNvPr>
              <p:cNvSpPr/>
              <p:nvPr/>
            </p:nvSpPr>
            <p:spPr>
              <a:xfrm>
                <a:off x="636813" y="931079"/>
                <a:ext cx="2579914" cy="859971"/>
              </a:xfrm>
              <a:prstGeom prst="rect">
                <a:avLst/>
              </a:prstGeom>
              <a:noFill/>
              <a:ln w="1905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endParaRPr sz="18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cxnSp>
          <p:nvCxnSpPr>
            <p:cNvPr id="8" name="Google Shape;79;p1">
              <a:extLst>
                <a:ext uri="{FF2B5EF4-FFF2-40B4-BE49-F238E27FC236}">
                  <a16:creationId xmlns:a16="http://schemas.microsoft.com/office/drawing/2014/main" id="{CEEFD361-70B7-164B-AC57-D38F232BC035}"/>
                </a:ext>
              </a:extLst>
            </p:cNvPr>
            <p:cNvCxnSpPr/>
            <p:nvPr/>
          </p:nvCxnSpPr>
          <p:spPr>
            <a:xfrm>
              <a:off x="2491916" y="5110819"/>
              <a:ext cx="0" cy="3060000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grpSp>
          <p:nvGrpSpPr>
            <p:cNvPr id="9" name="Google Shape;80;p1">
              <a:extLst>
                <a:ext uri="{FF2B5EF4-FFF2-40B4-BE49-F238E27FC236}">
                  <a16:creationId xmlns:a16="http://schemas.microsoft.com/office/drawing/2014/main" id="{45EA4411-F32A-B546-AC50-E0BF0183A682}"/>
                </a:ext>
              </a:extLst>
            </p:cNvPr>
            <p:cNvGrpSpPr/>
            <p:nvPr/>
          </p:nvGrpSpPr>
          <p:grpSpPr>
            <a:xfrm>
              <a:off x="2491916" y="5666940"/>
              <a:ext cx="4544786" cy="1615300"/>
              <a:chOff x="1545767" y="2382268"/>
              <a:chExt cx="4544786" cy="1615300"/>
            </a:xfrm>
          </p:grpSpPr>
          <p:grpSp>
            <p:nvGrpSpPr>
              <p:cNvPr id="10" name="Google Shape;81;p1">
                <a:extLst>
                  <a:ext uri="{FF2B5EF4-FFF2-40B4-BE49-F238E27FC236}">
                    <a16:creationId xmlns:a16="http://schemas.microsoft.com/office/drawing/2014/main" id="{F12A14CB-3C5E-FE4E-B197-864CC21DF4B4}"/>
                  </a:ext>
                </a:extLst>
              </p:cNvPr>
              <p:cNvGrpSpPr/>
              <p:nvPr/>
            </p:nvGrpSpPr>
            <p:grpSpPr>
              <a:xfrm>
                <a:off x="3047997" y="2382268"/>
                <a:ext cx="3042556" cy="1615300"/>
                <a:chOff x="3565072" y="3043785"/>
                <a:chExt cx="3042556" cy="1615300"/>
              </a:xfrm>
            </p:grpSpPr>
            <p:sp>
              <p:nvSpPr>
                <p:cNvPr id="12" name="Google Shape;82;p1">
                  <a:extLst>
                    <a:ext uri="{FF2B5EF4-FFF2-40B4-BE49-F238E27FC236}">
                      <a16:creationId xmlns:a16="http://schemas.microsoft.com/office/drawing/2014/main" id="{20EA390A-C4D4-C044-80B0-4DD538F9C69C}"/>
                    </a:ext>
                  </a:extLst>
                </p:cNvPr>
                <p:cNvSpPr txBox="1"/>
                <p:nvPr/>
              </p:nvSpPr>
              <p:spPr>
                <a:xfrm>
                  <a:off x="3565072" y="3076443"/>
                  <a:ext cx="3042556" cy="138499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400"/>
                    <a:buFont typeface="Arial"/>
                    <a:buNone/>
                  </a:pPr>
                  <a:r>
                    <a:rPr lang="en-CA" sz="14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Excluded: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  <a:p>
                  <a:pPr marL="285750" marR="0" lvl="0" indent="-28575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1400"/>
                    <a:buFont typeface="Calibri"/>
                    <a:buChar char="-"/>
                  </a:pPr>
                  <a:r>
                    <a:rPr lang="en-CA" sz="14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10 (5 doubles entries with     	different answers)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  <a:p>
                  <a:pPr marL="285750" marR="0" lvl="0" indent="-28575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1400"/>
                    <a:buFont typeface="Calibri"/>
                    <a:buChar char="-"/>
                  </a:pPr>
                  <a:r>
                    <a:rPr lang="en-CA" sz="14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8 non understandable answers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  <a:p>
                  <a:pPr marL="285750" marR="0" lvl="0" indent="-28575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1400"/>
                    <a:buFont typeface="Calibri"/>
                    <a:buChar char="-"/>
                  </a:pPr>
                  <a:r>
                    <a:rPr lang="en-CA" sz="14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7 incomplete answers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  <a:p>
                  <a:pPr marL="285750" marR="0" lvl="0" indent="-28575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chemeClr val="dk1"/>
                    </a:buClr>
                    <a:buSzPts val="1400"/>
                    <a:buFont typeface="Calibri"/>
                    <a:buChar char="-"/>
                  </a:pPr>
                  <a:r>
                    <a:rPr lang="en-CA" sz="1400" b="1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2 unreadable forms	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3" name="Google Shape;83;p1">
                  <a:extLst>
                    <a:ext uri="{FF2B5EF4-FFF2-40B4-BE49-F238E27FC236}">
                      <a16:creationId xmlns:a16="http://schemas.microsoft.com/office/drawing/2014/main" id="{FE50D598-06C7-4B48-BA3A-B9845E80612B}"/>
                    </a:ext>
                  </a:extLst>
                </p:cNvPr>
                <p:cNvSpPr/>
                <p:nvPr/>
              </p:nvSpPr>
              <p:spPr>
                <a:xfrm>
                  <a:off x="3565072" y="3043785"/>
                  <a:ext cx="2708728" cy="1615300"/>
                </a:xfrm>
                <a:prstGeom prst="rect">
                  <a:avLst/>
                </a:prstGeom>
                <a:noFill/>
                <a:ln w="1905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800"/>
                    <a:buFont typeface="Arial"/>
                    <a:buNone/>
                  </a:pPr>
                  <a:endParaRPr sz="1800" b="0" i="0" u="none" strike="noStrike" cap="none">
                    <a:solidFill>
                      <a:schemeClr val="lt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cxnSp>
            <p:nvCxnSpPr>
              <p:cNvPr id="11" name="Google Shape;84;p1">
                <a:extLst>
                  <a:ext uri="{FF2B5EF4-FFF2-40B4-BE49-F238E27FC236}">
                    <a16:creationId xmlns:a16="http://schemas.microsoft.com/office/drawing/2014/main" id="{EC40DD76-7728-EE4F-9D26-F8E529AD97EC}"/>
                  </a:ext>
                </a:extLst>
              </p:cNvPr>
              <p:cNvCxnSpPr/>
              <p:nvPr/>
            </p:nvCxnSpPr>
            <p:spPr>
              <a:xfrm rot="10800000" flipH="1">
                <a:off x="1545767" y="3189918"/>
                <a:ext cx="1502230" cy="21771"/>
              </a:xfrm>
              <a:prstGeom prst="straightConnector1">
                <a:avLst/>
              </a:prstGeom>
              <a:noFill/>
              <a:ln w="1905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</p:grpSp>
        <p:grpSp>
          <p:nvGrpSpPr>
            <p:cNvPr id="14" name="Google Shape;85;p1">
              <a:extLst>
                <a:ext uri="{FF2B5EF4-FFF2-40B4-BE49-F238E27FC236}">
                  <a16:creationId xmlns:a16="http://schemas.microsoft.com/office/drawing/2014/main" id="{1CFAC039-4C48-E741-BE33-66EBDC5B3DF9}"/>
                </a:ext>
              </a:extLst>
            </p:cNvPr>
            <p:cNvGrpSpPr/>
            <p:nvPr/>
          </p:nvGrpSpPr>
          <p:grpSpPr>
            <a:xfrm>
              <a:off x="1203774" y="8187538"/>
              <a:ext cx="2581729" cy="859971"/>
              <a:chOff x="636813" y="931079"/>
              <a:chExt cx="2581729" cy="859971"/>
            </a:xfrm>
          </p:grpSpPr>
          <p:sp>
            <p:nvSpPr>
              <p:cNvPr id="15" name="Google Shape;86;p1">
                <a:extLst>
                  <a:ext uri="{FF2B5EF4-FFF2-40B4-BE49-F238E27FC236}">
                    <a16:creationId xmlns:a16="http://schemas.microsoft.com/office/drawing/2014/main" id="{B654757D-3610-E842-B910-4A6CC5CA3152}"/>
                  </a:ext>
                </a:extLst>
              </p:cNvPr>
              <p:cNvSpPr txBox="1"/>
              <p:nvPr/>
            </p:nvSpPr>
            <p:spPr>
              <a:xfrm>
                <a:off x="638628" y="1126375"/>
                <a:ext cx="2579914" cy="3077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en-CA" sz="1400" b="1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382 participants for analysis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16" name="Google Shape;87;p1">
                <a:extLst>
                  <a:ext uri="{FF2B5EF4-FFF2-40B4-BE49-F238E27FC236}">
                    <a16:creationId xmlns:a16="http://schemas.microsoft.com/office/drawing/2014/main" id="{A2E84F39-9F84-6D48-9052-9988D5FC22FF}"/>
                  </a:ext>
                </a:extLst>
              </p:cNvPr>
              <p:cNvSpPr/>
              <p:nvPr/>
            </p:nvSpPr>
            <p:spPr>
              <a:xfrm>
                <a:off x="636813" y="931079"/>
                <a:ext cx="2579914" cy="859971"/>
              </a:xfrm>
              <a:prstGeom prst="rect">
                <a:avLst/>
              </a:prstGeom>
              <a:noFill/>
              <a:ln w="1905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endParaRPr sz="18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3461B40-EBD3-8D40-A811-9EEE4E3F6F84}"/>
                </a:ext>
              </a:extLst>
            </p:cNvPr>
            <p:cNvSpPr txBox="1"/>
            <p:nvPr/>
          </p:nvSpPr>
          <p:spPr>
            <a:xfrm>
              <a:off x="268941" y="1644789"/>
              <a:ext cx="35092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upplementary figure S1. Flow chart of participants </a:t>
              </a:r>
              <a:endParaRPr lang="fr-FR" sz="1200" dirty="0"/>
            </a:p>
          </p:txBody>
        </p:sp>
        <p:cxnSp>
          <p:nvCxnSpPr>
            <p:cNvPr id="17" name="Google Shape;79;p1">
              <a:extLst>
                <a:ext uri="{FF2B5EF4-FFF2-40B4-BE49-F238E27FC236}">
                  <a16:creationId xmlns:a16="http://schemas.microsoft.com/office/drawing/2014/main" id="{82B7DDE4-D2E6-4AFE-8982-66169DE38CC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80473" y="3089437"/>
              <a:ext cx="12428" cy="1144692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grpSp>
          <p:nvGrpSpPr>
            <p:cNvPr id="19" name="Google Shape;76;p1">
              <a:extLst>
                <a:ext uri="{FF2B5EF4-FFF2-40B4-BE49-F238E27FC236}">
                  <a16:creationId xmlns:a16="http://schemas.microsoft.com/office/drawing/2014/main" id="{0151B661-44B1-44D1-A19D-4D88B1B19BF7}"/>
                </a:ext>
              </a:extLst>
            </p:cNvPr>
            <p:cNvGrpSpPr/>
            <p:nvPr/>
          </p:nvGrpSpPr>
          <p:grpSpPr>
            <a:xfrm>
              <a:off x="1089651" y="2001907"/>
              <a:ext cx="2804527" cy="1087530"/>
              <a:chOff x="634997" y="931079"/>
              <a:chExt cx="2581730" cy="859971"/>
            </a:xfrm>
          </p:grpSpPr>
          <p:sp>
            <p:nvSpPr>
              <p:cNvPr id="20" name="Google Shape;77;p1">
                <a:extLst>
                  <a:ext uri="{FF2B5EF4-FFF2-40B4-BE49-F238E27FC236}">
                    <a16:creationId xmlns:a16="http://schemas.microsoft.com/office/drawing/2014/main" id="{1A7301CB-94D7-4692-89B1-1E62CF2C1A96}"/>
                  </a:ext>
                </a:extLst>
              </p:cNvPr>
              <p:cNvSpPr txBox="1"/>
              <p:nvPr/>
            </p:nvSpPr>
            <p:spPr>
              <a:xfrm>
                <a:off x="634997" y="991752"/>
                <a:ext cx="2579914" cy="73862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en-CA" sz="1400" b="1" i="0" u="none" strike="noStrike" cap="none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(500) Number of potential participants reached through advertisements at community centres</a:t>
                </a:r>
                <a:endParaRPr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21" name="Google Shape;78;p1">
                <a:extLst>
                  <a:ext uri="{FF2B5EF4-FFF2-40B4-BE49-F238E27FC236}">
                    <a16:creationId xmlns:a16="http://schemas.microsoft.com/office/drawing/2014/main" id="{97B27B81-1A8B-4059-AB37-FAC0976D91EC}"/>
                  </a:ext>
                </a:extLst>
              </p:cNvPr>
              <p:cNvSpPr/>
              <p:nvPr/>
            </p:nvSpPr>
            <p:spPr>
              <a:xfrm>
                <a:off x="636813" y="931079"/>
                <a:ext cx="2579914" cy="859971"/>
              </a:xfrm>
              <a:prstGeom prst="rect">
                <a:avLst/>
              </a:prstGeom>
              <a:noFill/>
              <a:ln w="1905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endParaRPr sz="18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02679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0275D8D-7E75-2C41-9597-48D138885834}"/>
              </a:ext>
            </a:extLst>
          </p:cNvPr>
          <p:cNvGrpSpPr/>
          <p:nvPr/>
        </p:nvGrpSpPr>
        <p:grpSpPr>
          <a:xfrm>
            <a:off x="7843" y="1442059"/>
            <a:ext cx="6734739" cy="3712398"/>
            <a:chOff x="7843" y="1442059"/>
            <a:chExt cx="6734739" cy="3712398"/>
          </a:xfrm>
        </p:grpSpPr>
        <p:sp>
          <p:nvSpPr>
            <p:cNvPr id="78" name="Google Shape;78;gb94cefe6b1_1_0"/>
            <p:cNvSpPr txBox="1"/>
            <p:nvPr/>
          </p:nvSpPr>
          <p:spPr>
            <a:xfrm>
              <a:off x="7843" y="1442059"/>
              <a:ext cx="6335400" cy="276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CA" sz="1200" b="1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Supplementary figure S2.  The distribution of travel destination of FISSA who had traveled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02F6009C-7C05-4FF2-8A14-2261B3ADD1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484" t="5373" r="4942" b="12221"/>
            <a:stretch/>
          </p:blipFill>
          <p:spPr>
            <a:xfrm>
              <a:off x="115418" y="1790675"/>
              <a:ext cx="6627164" cy="33637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3AD1D26-9E1D-4C4E-BA1E-B44E876CA997}"/>
              </a:ext>
            </a:extLst>
          </p:cNvPr>
          <p:cNvGrpSpPr/>
          <p:nvPr/>
        </p:nvGrpSpPr>
        <p:grpSpPr>
          <a:xfrm>
            <a:off x="-21900" y="148493"/>
            <a:ext cx="6880025" cy="8575754"/>
            <a:chOff x="-21900" y="148493"/>
            <a:chExt cx="6880025" cy="8575754"/>
          </a:xfrm>
        </p:grpSpPr>
        <p:sp>
          <p:nvSpPr>
            <p:cNvPr id="83" name="Google Shape;83;p7"/>
            <p:cNvSpPr txBox="1"/>
            <p:nvPr/>
          </p:nvSpPr>
          <p:spPr>
            <a:xfrm>
              <a:off x="-21900" y="148493"/>
              <a:ext cx="6879900" cy="321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CA" sz="1200" b="1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Supplementary </a:t>
              </a:r>
              <a:r>
                <a:rPr lang="en-CA" sz="12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table S1</a:t>
              </a:r>
              <a:r>
                <a:rPr lang="en-CA" sz="1200" b="1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. Participant’s attitudes regarding malaria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aphicFrame>
          <p:nvGraphicFramePr>
            <p:cNvPr id="84" name="Google Shape;84;p7"/>
            <p:cNvGraphicFramePr/>
            <p:nvPr>
              <p:extLst>
                <p:ext uri="{D42A27DB-BD31-4B8C-83A1-F6EECF244321}">
                  <p14:modId xmlns:p14="http://schemas.microsoft.com/office/powerpoint/2010/main" val="1841590026"/>
                </p:ext>
              </p:extLst>
            </p:nvPr>
          </p:nvGraphicFramePr>
          <p:xfrm>
            <a:off x="0" y="471676"/>
            <a:ext cx="6858000" cy="7456205"/>
          </p:xfrm>
          <a:graphic>
            <a:graphicData uri="http://schemas.openxmlformats.org/drawingml/2006/table">
              <a:tbl>
                <a:tblPr>
                  <a:noFill/>
                  <a:tableStyleId>{5CE32713-2377-47DB-8176-DB4D2CB9FCFD}</a:tableStyleId>
                </a:tblPr>
                <a:tblGrid>
                  <a:gridCol w="5477375">
                    <a:extLst>
                      <a:ext uri="{9D8B030D-6E8A-4147-A177-3AD203B41FA5}">
                        <a16:colId xmlns:a16="http://schemas.microsoft.com/office/drawing/2014/main" val="20000"/>
                      </a:ext>
                    </a:extLst>
                  </a:gridCol>
                  <a:gridCol w="1380625">
                    <a:extLst>
                      <a:ext uri="{9D8B030D-6E8A-4147-A177-3AD203B41FA5}">
                        <a16:colId xmlns:a16="http://schemas.microsoft.com/office/drawing/2014/main" val="20001"/>
                      </a:ext>
                    </a:extLst>
                  </a:gridCol>
                </a:tblGrid>
                <a:tr h="258375">
                  <a:tc gridSpan="2">
                    <a:txBody>
                      <a:bodyPr/>
                      <a:lstStyle/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200"/>
                          <a:buFont typeface="Arial"/>
                          <a:buNone/>
                        </a:pPr>
                        <a:r>
                          <a:rPr lang="en-CA" sz="1200" b="1" u="none" strike="noStrike" cap="non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Parameter                                                                                                           Frequency, n=382 (Percentage %)</a:t>
                        </a:r>
                        <a:endParaRPr sz="1200" b="1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a:txBody>
                    <a:tcPr marL="91450" marR="91450" marT="45725" marB="45725">
                      <a:lnL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12700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12700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  <a:solidFill>
                        <a:srgbClr val="D8D8D8"/>
                      </a:solidFill>
                    </a:tcPr>
                  </a:tc>
                  <a:tc hMerge="1">
                    <a:txBody>
                      <a:bodyPr/>
                      <a:lstStyle/>
                      <a:p>
                        <a:endParaRPr lang="fr-FR"/>
                      </a:p>
                    </a:txBody>
                    <a:tcPr/>
                  </a:tc>
                  <a:extLst>
                    <a:ext uri="{0D108BD9-81ED-4DB2-BD59-A6C34878D82A}">
                      <a16:rowId xmlns:a16="http://schemas.microsoft.com/office/drawing/2014/main" val="10000"/>
                    </a:ext>
                  </a:extLst>
                </a:tr>
                <a:tr h="651525">
                  <a:tc>
                    <a:txBody>
                      <a:bodyPr/>
                      <a:lstStyle/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200"/>
                          <a:buFont typeface="Arial"/>
                          <a:buNone/>
                        </a:pPr>
                        <a:r>
                          <a:rPr lang="en-CA" sz="1100" b="1" u="sng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Affective</a:t>
                        </a:r>
                        <a:r>
                          <a:rPr lang="en-CA" sz="1100" b="1" u="none" strike="noStrike" cap="none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(a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2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High perceived risk of contracting malaria</a:t>
                        </a:r>
                        <a:r>
                          <a:rPr lang="en-CA" sz="1100" b="1" u="none" strike="noStrike" cap="none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(b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2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High perceived risk of malaria as a mortal disease</a:t>
                        </a:r>
                        <a:r>
                          <a:rPr lang="en-CA" sz="1100" b="1" u="none" strike="noStrike" cap="none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(c)</a:t>
                        </a:r>
                        <a:r>
                          <a:rPr lang="en-CA" sz="1100" b="1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</a:t>
                        </a:r>
                        <a:endParaRPr sz="1400" u="none" strike="noStrike" cap="none" dirty="0"/>
                      </a:p>
                    </a:txBody>
                    <a:tcPr marL="91450" marR="91450" marT="45725" marB="45725">
                      <a:lnL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12700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  <a:solidFill>
                        <a:schemeClr val="lt1"/>
                      </a:solidFill>
                    </a:tcPr>
                  </a:tc>
                  <a:tc>
                    <a:txBody>
                      <a:bodyPr/>
                      <a:lstStyle/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45 (70)</a:t>
                        </a:r>
                        <a:endParaRPr sz="1400" u="none" strike="noStrike" cap="none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09 (61)</a:t>
                        </a:r>
                        <a:endParaRPr sz="1400" u="none" strike="noStrike" cap="none"/>
                      </a:p>
                    </a:txBody>
                    <a:tcPr marL="91450" marR="91450" marT="45725" marB="45725">
                      <a:lnL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12700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  <a:solidFill>
                        <a:schemeClr val="lt1"/>
                      </a:solidFill>
                    </a:tcPr>
                  </a:tc>
                  <a:extLst>
                    <a:ext uri="{0D108BD9-81ED-4DB2-BD59-A6C34878D82A}">
                      <a16:rowId xmlns:a16="http://schemas.microsoft.com/office/drawing/2014/main" val="10001"/>
                    </a:ext>
                  </a:extLst>
                </a:tr>
                <a:tr h="6258450">
                  <a:tc>
                    <a:txBody>
                      <a:bodyPr/>
                      <a:lstStyle/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100" b="1" u="sng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Cognitive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5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It is rare for malaria in adults to be severe</a:t>
                        </a:r>
                        <a:endParaRPr sz="105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malaria is severe in everyone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o response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endParaRPr sz="1000" b="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It is rare for malaria in children to be severe</a:t>
                        </a:r>
                        <a:endParaRPr sz="11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 malaria is often severe in children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You can recognize malaria without using a blood test</a:t>
                        </a:r>
                        <a:endParaRPr sz="11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you always need a blood test to recognize malaria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Antimalarial drugs have many side effects</a:t>
                        </a:r>
                        <a:endParaRPr sz="11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 there are very few side effects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Malaria can be treated at home without visiting a doctor</a:t>
                        </a:r>
                        <a:endParaRPr sz="11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malaria is a deadly disease and should always be the subject of an opinion</a:t>
                        </a: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from a health professional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In Canada, antimalarial medication should be available at the pharmacy without the need for a doctor’s prescription</a:t>
                        </a:r>
                        <a:endParaRPr sz="11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we should never have access to antimalarial medication without a</a:t>
                        </a: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octor’s prescription</a:t>
                        </a:r>
                        <a:endParaRPr sz="1000" b="0" u="none" strike="noStrike" cap="none" dirty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100" b="1" u="sng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100" b="1" u="sng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Behavioral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100"/>
                          <a:buFont typeface="Arial"/>
                          <a:buNone/>
                        </a:pPr>
                        <a:r>
                          <a:rPr lang="en-CA" sz="1100" b="1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I will take my child to the doctor again if he ever has a fever</a:t>
                        </a:r>
                        <a:r>
                          <a:rPr lang="en-CA" sz="1100" b="1" u="none" strike="noStrike" cap="none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(</a:t>
                        </a:r>
                        <a:r>
                          <a:rPr lang="en-CA" sz="1100" b="1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d</a:t>
                        </a:r>
                        <a:r>
                          <a:rPr lang="en-CA" sz="1100" b="1" u="none" strike="noStrike" cap="none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 (</a:t>
                        </a:r>
                        <a:r>
                          <a:rPr lang="en-CA" sz="1100" b="1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e</a:t>
                        </a:r>
                        <a:r>
                          <a:rPr lang="en-CA" sz="1100" b="1" u="none" strike="noStrike" cap="none" baseline="30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1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1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Agree/strongly agree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Neutral</a:t>
                        </a:r>
                        <a:endParaRPr sz="10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Disagree/strongly disagree, care is not adapted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100" b="1" u="sng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a:txBody>
                    <a:tcPr marL="91450" marR="91450" marT="45725" marB="45725">
                      <a:lnL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rgbClr val="000000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  <a:solidFill>
                        <a:schemeClr val="lt1"/>
                      </a:solidFill>
                    </a:tcPr>
                  </a:tc>
                  <a:tc>
                    <a:txBody>
                      <a:bodyPr/>
                      <a:lstStyle/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3 (6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1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4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9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8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7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8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6 (1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2 (6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66 (17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9</a:t>
                        </a:r>
                        <a:r>
                          <a:rPr lang="en-CA" sz="1000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4</a:t>
                        </a: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77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5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40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76 (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0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5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4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3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3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9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4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51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6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1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6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16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68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1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8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5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3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6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6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2</a:t>
                        </a:r>
                        <a:r>
                          <a:rPr lang="en-CA" sz="1000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4</a:t>
                        </a: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32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0</a:t>
                        </a:r>
                        <a:r>
                          <a:rPr lang="en-CA" sz="1000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8</a:t>
                        </a: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28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</a:t>
                        </a:r>
                        <a:r>
                          <a:rPr lang="en-CA" sz="1000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50</a:t>
                        </a: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3</a:t>
                        </a:r>
                        <a:r>
                          <a:rPr lang="en-CA" sz="1000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9</a:t>
                        </a:r>
                        <a:r>
                          <a:rPr lang="en-CA" sz="1000" u="none" strike="noStrike" cap="none" dirty="0"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3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2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 (5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4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106 (43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7 (</a:t>
                        </a:r>
                        <a:r>
                          <a:rPr lang="en-CA" sz="1000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3</a:t>
                        </a:r>
                        <a:r>
                          <a:rPr lang="en-CA" sz="1000" u="none" strike="noStrike" cap="none" dirty="0">
                            <a:solidFill>
                              <a:schemeClr val="dk1"/>
                            </a:solidFill>
                            <a:latin typeface="Calibri"/>
                            <a:ea typeface="Calibri"/>
                            <a:cs typeface="Calibri"/>
                            <a:sym typeface="Calibri"/>
                          </a:rPr>
                          <a:t>)</a:t>
                        </a:r>
                        <a:endParaRPr sz="1400" u="none" strike="noStrike" cap="none" dirty="0"/>
                      </a:p>
                      <a:p>
                        <a:pPr marL="0" marR="0" lvl="0" indent="0" algn="l" rtl="0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>
                            <a:srgbClr val="000000"/>
                          </a:buClr>
                          <a:buSzPts val="1000"/>
                          <a:buFont typeface="Arial"/>
                          <a:buNone/>
                        </a:pPr>
                        <a:endParaRPr sz="100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endParaRPr>
                      </a:p>
                    </a:txBody>
                    <a:tcPr marL="91450" marR="91450" marT="45725" marB="45725">
                      <a:lnL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rgbClr val="000000">
                            <a:alpha val="0"/>
                          </a:srgbClr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rgbClr val="000000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  <a:solidFill>
                        <a:schemeClr val="lt1"/>
                      </a:solidFill>
                    </a:tcPr>
                  </a:tc>
                  <a:extLst>
                    <a:ext uri="{0D108BD9-81ED-4DB2-BD59-A6C34878D82A}">
                      <a16:rowId xmlns:a16="http://schemas.microsoft.com/office/drawing/2014/main" val="10002"/>
                    </a:ext>
                  </a:extLst>
                </a:tr>
              </a:tbl>
            </a:graphicData>
          </a:graphic>
        </p:graphicFrame>
        <p:sp>
          <p:nvSpPr>
            <p:cNvPr id="85" name="Google Shape;85;p7"/>
            <p:cNvSpPr txBox="1"/>
            <p:nvPr/>
          </p:nvSpPr>
          <p:spPr>
            <a:xfrm>
              <a:off x="-21775" y="7932247"/>
              <a:ext cx="6879900" cy="792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00"/>
                <a:buFont typeface="Arial"/>
                <a:buNone/>
              </a:pPr>
              <a:r>
                <a:rPr lang="en-CA" sz="800" b="0" i="0" u="none" strike="noStrike" cap="none" baseline="300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(a) </a:t>
              </a:r>
              <a:r>
                <a:rPr lang="en-CA" sz="800" b="0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High perceived risk corresponds to ratings &gt;5</a:t>
              </a:r>
              <a:endParaRPr sz="8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00"/>
                <a:buFont typeface="Arial"/>
                <a:buNone/>
              </a:pPr>
              <a:r>
                <a:rPr lang="en-CA" sz="800" b="0" i="0" u="none" strike="noStrike" cap="none" baseline="30000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(b) </a:t>
              </a:r>
              <a:r>
                <a:rPr lang="en-CA" sz="800" b="0" i="0" u="none" strike="noStrike" cap="none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n=349. Excludes participants who did not answer or answered ambiguously</a:t>
              </a:r>
              <a:endParaRPr sz="8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00"/>
                <a:buFont typeface="Arial"/>
                <a:buNone/>
              </a:pPr>
              <a:r>
                <a:rPr lang="en-CA" sz="800" b="0" i="0" u="none" strike="noStrike" cap="none" baseline="30000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(c)</a:t>
              </a:r>
              <a:r>
                <a:rPr lang="en-CA" sz="800" b="0" i="0" u="none" strike="noStrike" cap="none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 n=343. Excludes participants who did not answer or answered ambiguously</a:t>
              </a:r>
              <a:endParaRPr sz="8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00"/>
                <a:buFont typeface="Arial"/>
                <a:buNone/>
              </a:pPr>
              <a:r>
                <a:rPr lang="en-CA" sz="800" b="0" i="0" u="none" strike="noStrike" cap="none" baseline="30000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(d) </a:t>
              </a:r>
              <a:r>
                <a:rPr lang="en-CA" sz="800" b="0" i="0" u="none" strike="noStrike" cap="none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n=244. Excludes participants who answered “I have no children”</a:t>
              </a:r>
              <a:endParaRPr sz="8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  <a:p>
              <a:pPr marL="0" marR="0" lvl="0" indent="0" algn="l" rtl="0">
                <a:lnSpc>
                  <a:spcPct val="115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800"/>
                <a:buFont typeface="Arial"/>
                <a:buNone/>
              </a:pPr>
              <a:r>
                <a:rPr lang="en-CA" sz="800" b="0" i="0" u="none" strike="noStrike" cap="none" baseline="30000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(e) </a:t>
              </a:r>
              <a:r>
                <a:rPr lang="en-CA" sz="800" b="0" i="0" u="none" strike="noStrike" cap="none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Full question is as follows: If your child had a fever after travelling to Africa, Latin America, or Asia and you took him/her to see the doctor; do you agree with the following statement.</a:t>
              </a:r>
              <a:endParaRPr sz="8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556</Words>
  <Application>Microsoft Macintosh PowerPoint</Application>
  <PresentationFormat>A4 Paper (210x297 mm)</PresentationFormat>
  <Paragraphs>104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 A</dc:creator>
  <cp:lastModifiedBy>Microsoft Office User</cp:lastModifiedBy>
  <cp:revision>16</cp:revision>
  <dcterms:modified xsi:type="dcterms:W3CDTF">2022-04-16T12:33:35Z</dcterms:modified>
</cp:coreProperties>
</file>